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5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78" y="180"/>
      </p:cViewPr>
      <p:guideLst>
        <p:guide orient="horz" pos="2160"/>
        <p:guide pos="285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FF691D-DA28-4B09-BBAD-507862F290E7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BB79CC-D343-4D4D-8062-EEC0CD54B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440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B93A49-0330-42B8-92C5-BCC12248ECC6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17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157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846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016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25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353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32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463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33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44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965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599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C169F-A293-47DC-955E-891FABE3AC78}" type="datetimeFigureOut">
              <a:rPr lang="en-US" smtClean="0"/>
              <a:t>2/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742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Table 8">
            <a:extLst>
              <a:ext uri="{FF2B5EF4-FFF2-40B4-BE49-F238E27FC236}">
                <a16:creationId xmlns:a16="http://schemas.microsoft.com/office/drawing/2014/main" id="{98F59ABF-EF32-43D7-A4D2-7926E3E615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0109624"/>
              </p:ext>
            </p:extLst>
          </p:nvPr>
        </p:nvGraphicFramePr>
        <p:xfrm>
          <a:off x="665324" y="1002014"/>
          <a:ext cx="8007038" cy="4581405"/>
        </p:xfrm>
        <a:graphic>
          <a:graphicData uri="http://schemas.openxmlformats.org/drawingml/2006/table">
            <a:tbl>
              <a:tblPr/>
              <a:tblGrid>
                <a:gridCol w="555021">
                  <a:extLst>
                    <a:ext uri="{9D8B030D-6E8A-4147-A177-3AD203B41FA5}">
                      <a16:colId xmlns:a16="http://schemas.microsoft.com/office/drawing/2014/main" val="2800065591"/>
                    </a:ext>
                  </a:extLst>
                </a:gridCol>
                <a:gridCol w="602619">
                  <a:extLst>
                    <a:ext uri="{9D8B030D-6E8A-4147-A177-3AD203B41FA5}">
                      <a16:colId xmlns:a16="http://schemas.microsoft.com/office/drawing/2014/main" val="2682672672"/>
                    </a:ext>
                  </a:extLst>
                </a:gridCol>
                <a:gridCol w="1574754">
                  <a:extLst>
                    <a:ext uri="{9D8B030D-6E8A-4147-A177-3AD203B41FA5}">
                      <a16:colId xmlns:a16="http://schemas.microsoft.com/office/drawing/2014/main" val="878788545"/>
                    </a:ext>
                  </a:extLst>
                </a:gridCol>
                <a:gridCol w="755520">
                  <a:extLst>
                    <a:ext uri="{9D8B030D-6E8A-4147-A177-3AD203B41FA5}">
                      <a16:colId xmlns:a16="http://schemas.microsoft.com/office/drawing/2014/main" val="496911545"/>
                    </a:ext>
                  </a:extLst>
                </a:gridCol>
                <a:gridCol w="803773">
                  <a:extLst>
                    <a:ext uri="{9D8B030D-6E8A-4147-A177-3AD203B41FA5}">
                      <a16:colId xmlns:a16="http://schemas.microsoft.com/office/drawing/2014/main" val="901905630"/>
                    </a:ext>
                  </a:extLst>
                </a:gridCol>
                <a:gridCol w="443202">
                  <a:extLst>
                    <a:ext uri="{9D8B030D-6E8A-4147-A177-3AD203B41FA5}">
                      <a16:colId xmlns:a16="http://schemas.microsoft.com/office/drawing/2014/main" val="2096136607"/>
                    </a:ext>
                  </a:extLst>
                </a:gridCol>
                <a:gridCol w="1401979">
                  <a:extLst>
                    <a:ext uri="{9D8B030D-6E8A-4147-A177-3AD203B41FA5}">
                      <a16:colId xmlns:a16="http://schemas.microsoft.com/office/drawing/2014/main" val="279819546"/>
                    </a:ext>
                  </a:extLst>
                </a:gridCol>
                <a:gridCol w="784367">
                  <a:extLst>
                    <a:ext uri="{9D8B030D-6E8A-4147-A177-3AD203B41FA5}">
                      <a16:colId xmlns:a16="http://schemas.microsoft.com/office/drawing/2014/main" val="44675807"/>
                    </a:ext>
                  </a:extLst>
                </a:gridCol>
                <a:gridCol w="1085803">
                  <a:extLst>
                    <a:ext uri="{9D8B030D-6E8A-4147-A177-3AD203B41FA5}">
                      <a16:colId xmlns:a16="http://schemas.microsoft.com/office/drawing/2014/main" val="319685044"/>
                    </a:ext>
                  </a:extLst>
                </a:gridCol>
              </a:tblGrid>
              <a:tr h="130671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ient #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utations</a:t>
                      </a:r>
                    </a:p>
                  </a:txBody>
                  <a:tcPr marL="6534" marR="6534" marT="65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py number variants</a:t>
                      </a:r>
                    </a:p>
                  </a:txBody>
                  <a:tcPr marL="6534" marR="6534" marT="653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thers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nal diagnosis after review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8288271"/>
                  </a:ext>
                </a:extLst>
              </a:tr>
              <a:tr h="22214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ucleotide change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ino acid change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llele frequency (%)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ene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py number altera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0852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 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5858C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 T1953I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4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M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ngle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bined LCNEC and SCL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7E6E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1116909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ID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1095del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R366Gfs*5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p (74 copies)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mbined LCNEC and SCL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081985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AD50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449C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Q817*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ND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p (56 copies)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948843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CA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1504_1508delTTAA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L502Afs*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6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T grade 2/atypical carcinoid, pancreas or lung primary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6710500"/>
                  </a:ext>
                </a:extLst>
              </a:tr>
              <a:tr h="192231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RAS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35G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 G12V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mall cell of unknown primary- Hepatobiliary origin suspected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7317591"/>
                  </a:ext>
                </a:extLst>
              </a:tr>
              <a:tr h="10727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326-2A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7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9887836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RX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5787-1G&gt;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82099988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482C&gt;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A161D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1192491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630_637delCACTTTT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N210Kfs*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13178830"/>
                  </a:ext>
                </a:extLst>
              </a:tr>
              <a:tr h="0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3587C&gt;A 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S1196*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5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L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250629"/>
                  </a:ext>
                </a:extLst>
              </a:tr>
              <a:tr h="13067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463_464TA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Y155fs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6385343"/>
                  </a:ext>
                </a:extLst>
              </a:tr>
              <a:tr h="6948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824G&gt;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C275Y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4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62362610"/>
                  </a:ext>
                </a:extLst>
              </a:tr>
              <a:tr h="13067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*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L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3267750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DKN2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38C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R80*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orly differentiated carcinom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0673286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RAS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181C&gt;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Q61K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0472048"/>
                  </a:ext>
                </a:extLst>
              </a:tr>
              <a:tr h="22000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573T&gt;G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L858R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wo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SCLC undergoing de novo SCLC transforma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420747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581_2583delCTGinsTT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L861F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84399807"/>
                  </a:ext>
                </a:extLst>
              </a:tr>
              <a:tr h="0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640_644delATTT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F216Vfs*7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6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OX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mp (31 copies)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CLC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74189214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469G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V157F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4741418"/>
                  </a:ext>
                </a:extLst>
              </a:tr>
              <a:tr h="24336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GFR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573T&gt;G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L858R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9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 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ngle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SCLC undergoing de novo SCLC transforma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94380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574C&gt;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Q192*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ngle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7484315"/>
                  </a:ext>
                </a:extLst>
              </a:tr>
              <a:tr h="12717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R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255_257delGCA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Q88del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B1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ngle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 TMPRSS2-ERG rearrangement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astatic prostate cancer, with small cel transforma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4970913"/>
                  </a:ext>
                </a:extLst>
              </a:tr>
              <a:tr h="5300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.897dupG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.P300Afs*6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7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P53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ngle copy deletion</a:t>
                      </a:r>
                    </a:p>
                  </a:txBody>
                  <a:tcPr marL="6534" marR="6534" marT="6534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EDED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3837587"/>
                  </a:ext>
                </a:extLst>
              </a:tr>
            </a:tbl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7384AFBC-D93B-4DDC-B3DA-704BA79498AA}"/>
              </a:ext>
            </a:extLst>
          </p:cNvPr>
          <p:cNvSpPr/>
          <p:nvPr/>
        </p:nvSpPr>
        <p:spPr>
          <a:xfrm>
            <a:off x="665324" y="5752237"/>
            <a:ext cx="144623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kern="100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R, none reporte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9844809-4218-44B9-88D9-F8A49A816778}"/>
              </a:ext>
            </a:extLst>
          </p:cNvPr>
          <p:cNvSpPr txBox="1"/>
          <p:nvPr/>
        </p:nvSpPr>
        <p:spPr>
          <a:xfrm>
            <a:off x="665324" y="401850"/>
            <a:ext cx="800703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utations and gene amplification foun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ncoPane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equencing in 11 clinically diagnosed never/light smokers with SCLC</a:t>
            </a:r>
          </a:p>
          <a:p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74066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2</TotalTime>
  <Words>374</Words>
  <Application>Microsoft Office PowerPoint</Application>
  <PresentationFormat>On-screen Show (4:3)</PresentationFormat>
  <Paragraphs>16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MS Mincho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gino, Atsuko</dc:creator>
  <cp:lastModifiedBy>Ogino, Atsuko</cp:lastModifiedBy>
  <cp:revision>31</cp:revision>
  <dcterms:created xsi:type="dcterms:W3CDTF">2018-05-29T14:20:40Z</dcterms:created>
  <dcterms:modified xsi:type="dcterms:W3CDTF">2020-02-10T04:44:07Z</dcterms:modified>
</cp:coreProperties>
</file>